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D4599B-F93D-DCCD-48FE-E8D6763C31F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D8ECBCA-23D8-A94B-735D-022750C6080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B8B818-56E3-5FDA-563F-BB8B3BDF31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727587D-9D58-2401-A440-1C4F3724DB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4730B4-C3C3-23E7-AAAE-D525521863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90827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B78EA4-21EF-E95F-AEA7-282DE53953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AA03F9A-B69D-BF98-D0BF-A0049F8510C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2D63AA-6175-8272-0170-118C00AB9D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9D89FA-292F-B8B7-8E39-0A9251F7CD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9BB115-8651-64EA-A060-5C34229348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79741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D411517-2F99-21FC-FF9B-A3D19A553ED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9266705-F15A-B133-74DD-D5E879EE9B6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AAE95C-5792-348F-88CB-B24E74ACDB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ADDE9F-A203-E4F8-2A27-8C5C8F6AD6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C7D4A2C-8277-A501-FF5C-8743BC5478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0811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EDDDB8-920D-4445-534E-4B172AF065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825E4D3-DF69-DAA5-FC31-041FB8EA658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3ADBDF-5563-A4AB-9667-B047197946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2C1F96-39C9-ADF6-ED01-B37A739F59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838EA0-2FA6-59F5-7AAF-B8C1991166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28503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077103-EE6B-0F0E-849E-B451A4C68C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64623DC-429C-0958-3E1B-6B42F2BCCAB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7D4172-2F3C-B368-5637-E30B96F134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66023C-1E09-8D93-4143-73EB19CB35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CE2DC6-4BF1-5773-C54F-7594BEFD6B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61257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8DF3B0-2B6F-759D-3487-E1A1566B94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FD55164-5672-DDF4-6BF2-5F5027307DA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C287619-4612-D63A-F0F0-57B0F03B363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13BCE3F-57B6-01BF-9793-198AF1649E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A9E3255-A0E3-4E40-12EA-D707559235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F3A3F64-5C57-7BC6-9EA3-7A91B55BF2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12320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79E7D1-A58D-BF36-1C37-CB1ECF06BF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46B714C-9BC9-969C-15B5-682C092A21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B2BBAC0-5664-C1AD-5B4A-073CC694B50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A6CF51F-5CE8-29C0-1E9A-8190801F34F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FB6134F-C20D-AD7B-D0BC-7680719FFB0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C05765F-A406-FA0F-71AB-061D196377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05AB52C-89E2-01D5-F902-66D58F8C47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CFD79B0-2349-EB4B-65AC-BEE492CE30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04594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B557E2-B32F-4878-740A-C18E5E4604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AC8FA3C-EF0C-4AF1-1C2E-83BD501530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17E5C7D-A824-91C1-C1EB-2FFBCD531D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BB9D4CD-DBE9-6E5F-1743-C57A1A9CC6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13518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9530656-0A86-8B6F-9878-9546E832B2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C6CA142-E3A7-2064-98E1-E62238D290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2B55CF2-0BBB-DBDB-46D6-E857CDBE50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86761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FE9FC9-C422-58FA-2939-BE2EE31CC0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3626AC2-4BAE-37C0-F1C0-FBFCCF9A984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1F06DA8-8075-569E-2563-CA89569C52A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C3562E6-2750-3CC1-6CA4-7A113B41A8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7EDD253-9114-20BA-B2DD-F878FC1D5D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AEB05CA-19C0-071D-DB36-A63FE91A63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35484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29B6E9-DC05-4945-C153-6CF75780ED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C6DDF63-4F53-5818-0243-FD292844414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A58311E-2F1C-6415-B46F-17B6F133B7F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07C3151-D418-EF44-8CF0-C828B29F89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6FFB2E1-CE48-1719-6EA8-15FC40E338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A7EFDBD-6491-05BE-AB66-834C214D3F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78750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EF5F76D-4D78-9410-CBB4-06635C36B8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45FE8F0-FC23-80DC-88F8-AE0E1EEE463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6872130-7057-A9CC-CFC9-1F3F854C026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B3B7DA-64A8-2CBB-A4E9-5B4D9396D3A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F56305-8EEA-3960-713B-82580782D86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37635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89CFBDB3-4BFB-716C-97B0-80B55DCC34BE}"/>
              </a:ext>
            </a:extLst>
          </p:cNvPr>
          <p:cNvSpPr txBox="1"/>
          <p:nvPr/>
        </p:nvSpPr>
        <p:spPr>
          <a:xfrm>
            <a:off x="85725" y="5971708"/>
            <a:ext cx="11668125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3. Within environments correlation (</a:t>
            </a:r>
            <a:r>
              <a:rPr lang="en-US" sz="14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y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axis) between observed and predicted values for four models under the cross-validation scheme CV0 which mimics the prediction scenario of </a:t>
            </a:r>
            <a:r>
              <a:rPr lang="en-US" sz="14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lready tested 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enotypes in novel environments (predicting tested genotypes in unobserved environments); the </a:t>
            </a:r>
            <a:r>
              <a:rPr lang="en-US" sz="14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x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axis depicts the number of genotypes tested at each environment. Environments with correlations below zero are connected with a blue line. </a:t>
            </a:r>
            <a:endParaRPr lang="en-US" sz="14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endParaRPr lang="en-US" sz="14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 descr="Diagram, schematic, scatter chart&#10;&#10;Description automatically generated">
            <a:extLst>
              <a:ext uri="{FF2B5EF4-FFF2-40B4-BE49-F238E27FC236}">
                <a16:creationId xmlns:a16="http://schemas.microsoft.com/office/drawing/2014/main" id="{AAD767EB-6DFD-67D9-663D-084A213EC810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91802" y="5205"/>
            <a:ext cx="5899127" cy="5899127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3283413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66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ernandez Jarquin,Juan Diego</dc:creator>
  <cp:lastModifiedBy>Hernandez Jarquin,Juan Diego</cp:lastModifiedBy>
  <cp:revision>5</cp:revision>
  <dcterms:created xsi:type="dcterms:W3CDTF">2022-08-30T03:12:47Z</dcterms:created>
  <dcterms:modified xsi:type="dcterms:W3CDTF">2022-08-30T03:25:34Z</dcterms:modified>
</cp:coreProperties>
</file>